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1214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424" y="-96"/>
      </p:cViewPr>
      <p:guideLst>
        <p:guide orient="horz" pos="2160"/>
        <p:guide pos="19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5" y="2130426"/>
            <a:ext cx="520319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8210" y="3886200"/>
            <a:ext cx="428498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8015" y="274639"/>
            <a:ext cx="1377315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6070" y="274639"/>
            <a:ext cx="4029922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48" y="4406901"/>
            <a:ext cx="520319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48" y="2906713"/>
            <a:ext cx="520319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6070" y="1600201"/>
            <a:ext cx="270361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1712" y="1600201"/>
            <a:ext cx="2703618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1535113"/>
            <a:ext cx="270468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070" y="2174875"/>
            <a:ext cx="270468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9586" y="1535113"/>
            <a:ext cx="270574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9586" y="2174875"/>
            <a:ext cx="270574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1" y="273050"/>
            <a:ext cx="201389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3297" y="273051"/>
            <a:ext cx="3422033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6071" y="1435101"/>
            <a:ext cx="201389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9837" y="4800600"/>
            <a:ext cx="367284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9837" y="612775"/>
            <a:ext cx="367284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9837" y="5367338"/>
            <a:ext cx="367284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6070" y="274638"/>
            <a:ext cx="550926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1600201"/>
            <a:ext cx="550926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6070" y="6356351"/>
            <a:ext cx="142832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1479" y="6356351"/>
            <a:ext cx="193844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7003" y="6356351"/>
            <a:ext cx="142832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50" y="161925"/>
            <a:ext cx="2457450" cy="1971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2600" y="152400"/>
            <a:ext cx="2476500" cy="1971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975" y="2171700"/>
            <a:ext cx="2514600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2600" y="2181225"/>
            <a:ext cx="2457450" cy="2028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550" y="4210050"/>
            <a:ext cx="2457450" cy="1962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660400" y="6255663"/>
            <a:ext cx="53340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Additional file 1: Supplementary Figure 1 (A-E) – Checking of nuclear DNA contamination in isolated perennial ryegrass mtDNA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2001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Shofiqul Islam</cp:lastModifiedBy>
  <cp:revision>3</cp:revision>
  <dcterms:created xsi:type="dcterms:W3CDTF">2006-08-16T00:00:00Z</dcterms:created>
  <dcterms:modified xsi:type="dcterms:W3CDTF">2012-10-23T18:05:14Z</dcterms:modified>
</cp:coreProperties>
</file>